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DCB47-7B36-4096-AD20-7213B5B9A8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49B79-1E31-4E95-B28B-2C3E4D17F4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1D1EA-D0BA-4891-874B-117403302C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A8389-1D79-46AF-BA05-930CCCA61D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471C9-D4EC-439D-A65B-E2D5EA5135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A3210-5755-47D2-9558-CCCA4F706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CB214-AEA8-429D-BD5F-557B5704CA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F8EB5-900E-4575-8AA6-36BF153A6D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149BD-C4EC-4691-AA48-D1230AF484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FF6E1-695C-4DEF-BCBC-144A33D15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3D133-8C0C-4AF2-86D8-FAF6B5A18C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3F388-FB61-4EB7-A213-4B5BA6A040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106547-4F5D-4115-B77A-00DDA052172A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65080" y="131760"/>
            <a:ext cx="312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337680" y="204120"/>
            <a:ext cx="3950640" cy="6454800"/>
            <a:chOff x="337680" y="204120"/>
            <a:chExt cx="3950640" cy="6454800"/>
          </a:xfrm>
        </p:grpSpPr>
        <p:grpSp>
          <p:nvGrpSpPr>
            <p:cNvPr id="43" name=""/>
            <p:cNvGrpSpPr/>
            <p:nvPr/>
          </p:nvGrpSpPr>
          <p:grpSpPr>
            <a:xfrm>
              <a:off x="337680" y="225360"/>
              <a:ext cx="2132280" cy="4710240"/>
              <a:chOff x="337680" y="225360"/>
              <a:chExt cx="2132280" cy="4710240"/>
            </a:xfrm>
          </p:grpSpPr>
          <p:sp>
            <p:nvSpPr>
              <p:cNvPr id="44" name=""/>
              <p:cNvSpPr/>
              <p:nvPr/>
            </p:nvSpPr>
            <p:spPr>
              <a:xfrm>
                <a:off x="337680" y="1228320"/>
                <a:ext cx="17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 flipV="1">
                <a:off x="516600" y="837360"/>
                <a:ext cx="0" cy="39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516600" y="837720"/>
                <a:ext cx="126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 flipV="1">
                <a:off x="643680" y="436320"/>
                <a:ext cx="0" cy="401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643680" y="436320"/>
                <a:ext cx="52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 flipV="1">
                <a:off x="696240" y="34092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696240" y="341280"/>
                <a:ext cx="253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V="1">
                <a:off x="949680" y="277920"/>
                <a:ext cx="0" cy="63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949680" y="277920"/>
                <a:ext cx="158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flipV="1">
                <a:off x="1108080" y="22536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108080" y="2253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108080" y="27792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108080" y="320040"/>
                <a:ext cx="10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949680" y="34128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949680" y="415080"/>
                <a:ext cx="200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696240" y="436320"/>
                <a:ext cx="0" cy="115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696240" y="552600"/>
                <a:ext cx="401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V="1">
                <a:off x="1097640" y="50976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097640" y="510120"/>
                <a:ext cx="42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097640" y="55260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097640" y="605160"/>
                <a:ext cx="633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43680" y="837720"/>
                <a:ext cx="0" cy="485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643680" y="132336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V="1">
                <a:off x="738720" y="974880"/>
                <a:ext cx="0" cy="348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738720" y="974880"/>
                <a:ext cx="147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V="1">
                <a:off x="886320" y="84780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886320" y="84816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V="1">
                <a:off x="918000" y="742320"/>
                <a:ext cx="0" cy="105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918000" y="742680"/>
                <a:ext cx="147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V="1">
                <a:off x="1065960" y="6998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065960" y="700200"/>
                <a:ext cx="52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065960" y="74268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065960" y="795240"/>
                <a:ext cx="73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918000" y="848160"/>
                <a:ext cx="0" cy="83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918000" y="932400"/>
                <a:ext cx="115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V="1">
                <a:off x="1034280" y="88992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034280" y="890280"/>
                <a:ext cx="179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034280" y="93240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034280" y="985680"/>
                <a:ext cx="242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886320" y="974880"/>
                <a:ext cx="0" cy="147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886320" y="1122480"/>
                <a:ext cx="115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1002240" y="1080720"/>
                <a:ext cx="0" cy="41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002240" y="1080720"/>
                <a:ext cx="147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002240" y="112248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002240" y="1175760"/>
                <a:ext cx="179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738720" y="1323360"/>
                <a:ext cx="0" cy="29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738720" y="161928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flipV="1">
                <a:off x="833400" y="1460880"/>
                <a:ext cx="0" cy="158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833400" y="1460880"/>
                <a:ext cx="284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V="1">
                <a:off x="1118520" y="138636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118520" y="1386720"/>
                <a:ext cx="95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flipV="1">
                <a:off x="1213920" y="131256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213920" y="1312920"/>
                <a:ext cx="4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V="1">
                <a:off x="1255680" y="12704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255680" y="127080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255680" y="131292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255680" y="1365840"/>
                <a:ext cx="63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213920" y="138672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1213920" y="1460880"/>
                <a:ext cx="168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118520" y="146088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118520" y="1555560"/>
                <a:ext cx="27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833400" y="161928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833400" y="171432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V="1">
                <a:off x="865080" y="1650600"/>
                <a:ext cx="0" cy="63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865080" y="1650600"/>
                <a:ext cx="432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865080" y="171432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865080" y="1809360"/>
                <a:ext cx="887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V="1">
                <a:off x="1752120" y="174564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752120" y="1746000"/>
                <a:ext cx="443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752120" y="180936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752120" y="1883160"/>
                <a:ext cx="559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 flipV="1">
                <a:off x="2311560" y="1841040"/>
                <a:ext cx="0" cy="41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311560" y="1841040"/>
                <a:ext cx="63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311560" y="188316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311560" y="1936080"/>
                <a:ext cx="158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516600" y="1228320"/>
                <a:ext cx="0" cy="1341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516600" y="2569680"/>
                <a:ext cx="179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 flipV="1">
                <a:off x="696240" y="2178360"/>
                <a:ext cx="0" cy="39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696240" y="2178720"/>
                <a:ext cx="464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 flipV="1">
                <a:off x="1160640" y="207360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1160640" y="2073600"/>
                <a:ext cx="696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 flipV="1">
                <a:off x="1857960" y="203076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857960" y="2031120"/>
                <a:ext cx="157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1857960" y="207360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1857960" y="2126160"/>
                <a:ext cx="18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160640" y="2178720"/>
                <a:ext cx="0" cy="84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800" bIns="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1160640" y="2263320"/>
                <a:ext cx="369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V="1">
                <a:off x="1530360" y="22208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1530360" y="2221200"/>
                <a:ext cx="158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1530360" y="226332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1530360" y="2316240"/>
                <a:ext cx="24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696240" y="2569680"/>
                <a:ext cx="0" cy="30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696240" y="2876400"/>
                <a:ext cx="348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 flipV="1">
                <a:off x="1044720" y="2453400"/>
                <a:ext cx="0" cy="42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044720" y="2453400"/>
                <a:ext cx="316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 flipV="1">
                <a:off x="1361520" y="241092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1361520" y="2411280"/>
                <a:ext cx="168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361520" y="245340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361520" y="2506680"/>
                <a:ext cx="27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044720" y="2876400"/>
                <a:ext cx="0" cy="295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044720" y="3171600"/>
                <a:ext cx="63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 flipV="1">
                <a:off x="1108080" y="2643120"/>
                <a:ext cx="0" cy="528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108080" y="2643480"/>
                <a:ext cx="158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V="1">
                <a:off x="1266480" y="2601720"/>
                <a:ext cx="0" cy="41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040" bIns="-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1266480" y="2601720"/>
                <a:ext cx="115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1266480" y="264348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266480" y="269676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1108080" y="3171600"/>
                <a:ext cx="0" cy="453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1108080" y="362592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 flipV="1">
                <a:off x="1150560" y="2876400"/>
                <a:ext cx="0" cy="749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1150560" y="2876400"/>
                <a:ext cx="105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 flipV="1">
                <a:off x="1255680" y="2791440"/>
                <a:ext cx="0" cy="84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800" bIns="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255680" y="2791800"/>
                <a:ext cx="74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1255680" y="2876400"/>
                <a:ext cx="0" cy="83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255680" y="296064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 flipV="1">
                <a:off x="1276920" y="288612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1276920" y="2886480"/>
                <a:ext cx="169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1276920" y="2960640"/>
                <a:ext cx="0" cy="63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276920" y="302400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flipV="1">
                <a:off x="1298160" y="298116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1298160" y="298152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298160" y="302400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298160" y="3076560"/>
                <a:ext cx="73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1150560" y="3625920"/>
                <a:ext cx="0" cy="644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150560" y="4270320"/>
                <a:ext cx="10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 flipV="1">
                <a:off x="1160640" y="3815640"/>
                <a:ext cx="0" cy="453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1160640" y="3816000"/>
                <a:ext cx="126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 flipV="1">
                <a:off x="1287720" y="368892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287720" y="368928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 flipV="1">
                <a:off x="1319040" y="3562560"/>
                <a:ext cx="0" cy="1267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1319040" y="356256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 flipV="1">
                <a:off x="1414080" y="3446280"/>
                <a:ext cx="0" cy="115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1414080" y="34462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 flipV="1">
                <a:off x="1414080" y="3361680"/>
                <a:ext cx="0" cy="83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1414080" y="3362040"/>
                <a:ext cx="74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V="1">
                <a:off x="1488240" y="3287880"/>
                <a:ext cx="0" cy="74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1488240" y="3287880"/>
                <a:ext cx="4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 flipV="1">
                <a:off x="1530360" y="321372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1530360" y="3214080"/>
                <a:ext cx="74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 flipV="1">
                <a:off x="1604520" y="31712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1604520" y="3171600"/>
                <a:ext cx="10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604520" y="321408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604520" y="3267000"/>
                <a:ext cx="52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530360" y="3287880"/>
                <a:ext cx="0" cy="74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1530360" y="3362040"/>
                <a:ext cx="147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488240" y="3362040"/>
                <a:ext cx="0" cy="83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488240" y="3446280"/>
                <a:ext cx="18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414080" y="344628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414080" y="3541320"/>
                <a:ext cx="253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414080" y="3562560"/>
                <a:ext cx="0" cy="1267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414080" y="3689280"/>
                <a:ext cx="74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V="1">
                <a:off x="1488240" y="363672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488240" y="3636720"/>
                <a:ext cx="157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1488240" y="368928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1488240" y="3731760"/>
                <a:ext cx="18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1319040" y="3689280"/>
                <a:ext cx="0" cy="137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1319040" y="3826800"/>
                <a:ext cx="27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1287720" y="3816000"/>
                <a:ext cx="0" cy="158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287720" y="3974400"/>
                <a:ext cx="179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flipV="1">
                <a:off x="1467360" y="392184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1467360" y="39218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467360" y="397440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1467360" y="401688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1160640" y="4270320"/>
                <a:ext cx="0" cy="401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1160640" y="467136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flipV="1">
                <a:off x="1181880" y="4396680"/>
                <a:ext cx="0" cy="273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1181880" y="439704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flipV="1">
                <a:off x="1192680" y="4259520"/>
                <a:ext cx="0" cy="137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1192680" y="425988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flipV="1">
                <a:off x="1224360" y="4164120"/>
                <a:ext cx="0" cy="95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224360" y="416448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 flipV="1">
                <a:off x="1255680" y="411192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1255680" y="411192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1255680" y="416448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255680" y="420696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224360" y="425988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224360" y="435492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 flipV="1">
                <a:off x="1255680" y="430128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255680" y="4301640"/>
                <a:ext cx="147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255680" y="435492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255680" y="4397040"/>
                <a:ext cx="105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192680" y="4397040"/>
                <a:ext cx="0" cy="147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192680" y="4545000"/>
                <a:ext cx="83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 flipV="1">
                <a:off x="1276920" y="449208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1276920" y="449208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1276920" y="454500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1276920" y="4587120"/>
                <a:ext cx="52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1181880" y="4671360"/>
                <a:ext cx="0" cy="264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1181880" y="493560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V="1">
                <a:off x="1192680" y="4819680"/>
                <a:ext cx="0" cy="115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1192680" y="48196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 flipV="1">
                <a:off x="1235160" y="472428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1235160" y="4724640"/>
                <a:ext cx="83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 flipV="1">
                <a:off x="1319040" y="468180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1319040" y="468216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1319040" y="472464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1319040" y="4777200"/>
                <a:ext cx="337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1235160" y="481968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1235160" y="4924800"/>
                <a:ext cx="115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 flipV="1">
                <a:off x="1351080" y="4872240"/>
                <a:ext cx="0" cy="5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4" name=""/>
            <p:cNvSpPr/>
            <p:nvPr/>
          </p:nvSpPr>
          <p:spPr>
            <a:xfrm>
              <a:off x="1351800" y="4872240"/>
              <a:ext cx="31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351800" y="4925160"/>
              <a:ext cx="0" cy="4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351800" y="4967280"/>
              <a:ext cx="63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193040" y="4935960"/>
              <a:ext cx="0" cy="126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193040" y="5062320"/>
              <a:ext cx="83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516960" y="1228320"/>
              <a:ext cx="0" cy="474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16960" y="5970960"/>
              <a:ext cx="1605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V="1">
              <a:off x="2122200" y="5590440"/>
              <a:ext cx="0" cy="380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122200" y="5590440"/>
              <a:ext cx="42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flipV="1">
              <a:off x="2164680" y="5357880"/>
              <a:ext cx="0" cy="232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164680" y="5358240"/>
              <a:ext cx="179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V="1">
              <a:off x="2344320" y="5273640"/>
              <a:ext cx="0" cy="83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344320" y="5274000"/>
              <a:ext cx="20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flipV="1">
              <a:off x="2365560" y="5199840"/>
              <a:ext cx="0" cy="74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365560" y="5199840"/>
              <a:ext cx="52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V="1">
              <a:off x="2418120" y="515772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418120" y="5157720"/>
              <a:ext cx="63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418120" y="5199840"/>
              <a:ext cx="0" cy="52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120" bIns="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418120" y="5252760"/>
              <a:ext cx="295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365560" y="5274000"/>
              <a:ext cx="0" cy="73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365560" y="5347800"/>
              <a:ext cx="73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344320" y="5358240"/>
              <a:ext cx="0" cy="84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344320" y="5442840"/>
              <a:ext cx="31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164680" y="5590440"/>
              <a:ext cx="0" cy="2113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164680" y="5802120"/>
              <a:ext cx="20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flipV="1">
              <a:off x="2185920" y="5611680"/>
              <a:ext cx="0" cy="190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185920" y="5611680"/>
              <a:ext cx="73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V="1">
              <a:off x="2259720" y="5537520"/>
              <a:ext cx="0" cy="73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259720" y="5537880"/>
              <a:ext cx="158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2259720" y="5611680"/>
              <a:ext cx="0" cy="73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2259720" y="5685480"/>
              <a:ext cx="13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2396880" y="5632920"/>
              <a:ext cx="0" cy="52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396880" y="5632920"/>
              <a:ext cx="63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396880" y="5685480"/>
              <a:ext cx="0" cy="4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396880" y="5727960"/>
              <a:ext cx="63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185920" y="5802120"/>
              <a:ext cx="0" cy="200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185920" y="6002640"/>
              <a:ext cx="189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2375640" y="5897160"/>
              <a:ext cx="0" cy="10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375640" y="5897160"/>
              <a:ext cx="42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V="1">
              <a:off x="2418120" y="5823000"/>
              <a:ext cx="0" cy="74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418120" y="5823000"/>
              <a:ext cx="63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418120" y="5897160"/>
              <a:ext cx="0" cy="63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2418120" y="5960160"/>
              <a:ext cx="52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V="1">
              <a:off x="2470680" y="591840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470680" y="5918400"/>
              <a:ext cx="84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470680" y="5960160"/>
              <a:ext cx="0" cy="52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120" bIns="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470680" y="6013440"/>
              <a:ext cx="210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375640" y="6002640"/>
              <a:ext cx="0" cy="105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375640" y="6108480"/>
              <a:ext cx="115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122200" y="5970960"/>
              <a:ext cx="0" cy="390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122200" y="6361920"/>
              <a:ext cx="84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 flipV="1">
              <a:off x="2206800" y="6255720"/>
              <a:ext cx="0" cy="105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206800" y="6256080"/>
              <a:ext cx="379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flipV="1">
              <a:off x="2586960" y="6203160"/>
              <a:ext cx="0" cy="52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586960" y="6203160"/>
              <a:ext cx="285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2586960" y="6256080"/>
              <a:ext cx="0" cy="4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586960" y="6298200"/>
              <a:ext cx="94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206800" y="6361920"/>
              <a:ext cx="0" cy="10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206800" y="6467040"/>
              <a:ext cx="348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V="1">
              <a:off x="2555280" y="6392880"/>
              <a:ext cx="0" cy="73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2555280" y="6393240"/>
              <a:ext cx="855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2555280" y="6467040"/>
              <a:ext cx="0" cy="63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2555280" y="6530760"/>
              <a:ext cx="781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flipV="1">
              <a:off x="3336840" y="6487920"/>
              <a:ext cx="0" cy="4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3336840" y="6488280"/>
              <a:ext cx="4856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3336840" y="6530760"/>
              <a:ext cx="0" cy="52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3336840" y="6583320"/>
              <a:ext cx="516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1146600" y="2041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1g035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1157040" y="2991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2g032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180800" y="3942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438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1557360" y="4892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1g597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1761480" y="58428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530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1157040" y="6789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9g256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1170000" y="7639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306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252080" y="8586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8g343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1317960" y="9536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368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1186560" y="10486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160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1217880" y="11437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797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1346400" y="12391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5g459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1349640" y="13341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185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1423440" y="14292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481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441440" y="15242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6g053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334160" y="16192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543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2221200" y="17143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2g417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2412720" y="18093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5g322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2500560" y="19044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269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2054880" y="19998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8g074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088720" y="20948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158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727280" y="21898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2g513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803600" y="22845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593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579680" y="23796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199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676880" y="24746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642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1408680" y="25696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655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397520" y="26647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105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378440" y="27601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4g425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1476000" y="28551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5g149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368360" y="29502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2g400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1413000" y="30452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487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1652400" y="31402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560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1695960" y="32353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7g032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708560" y="33303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575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1719000" y="34254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072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703520" y="35208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4g377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684440" y="36158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129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719000" y="37105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692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620360" y="38055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725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516320" y="39006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079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529280" y="39956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728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314720" y="40906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1g674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307160" y="41857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577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429200" y="42811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174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1400040" y="43761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1g190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336680" y="44712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6g447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1360080" y="45662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313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378440" y="46612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4g559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687680" y="47563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5g243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419480" y="48513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511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450800" y="49464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208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302480" y="50418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573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2507040" y="51364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4g369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2750040" y="52315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671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479320" y="53265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5g24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429640" y="5421600"/>
              <a:ext cx="54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4g55560.2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2462400" y="5516640"/>
              <a:ext cx="678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At2g28550_TOE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497320" y="56116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5g030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500560" y="57067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378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519280" y="58021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7g131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592360" y="58971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604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711880" y="59922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038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521800" y="60764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536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909880" y="61718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6g432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711880" y="626688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303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447000" y="63619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601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848040" y="64569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549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889800" y="65520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2g392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9" name=""/>
          <p:cNvSpPr/>
          <p:nvPr/>
        </p:nvSpPr>
        <p:spPr>
          <a:xfrm>
            <a:off x="454320" y="242712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917640" y="13129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841680" y="7920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860760" y="5954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812880" y="9795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752760" y="1936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898560" y="4111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1324080" y="21207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1511640" y="166536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2063880" y="185112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835200" y="43340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1049400" y="4441680"/>
            <a:ext cx="199800" cy="777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831960" y="40021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1041480" y="4075200"/>
            <a:ext cx="190440" cy="619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1163880" y="23130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1076400" y="24987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833760" y="45180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844920" y="47116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1060560" y="4618080"/>
            <a:ext cx="21888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1060560" y="4799160"/>
            <a:ext cx="261720" cy="997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955800" y="2031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2149560" y="52135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2362320" y="63244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1265400" y="38275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1613160" y="192240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094200" y="638496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2200320" y="55436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2178360" y="58611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841680" y="27320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356000" y="5084640"/>
            <a:ext cx="144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494240" y="5081760"/>
            <a:ext cx="25200" cy="1581120"/>
          </a:xfrm>
          <a:custGeom>
            <a:avLst/>
            <a:gdLst/>
            <a:ahLst/>
            <a:rect l="l" t="t" r="r" b="b"/>
            <a:pathLst>
              <a:path w="16" h="996">
                <a:moveTo>
                  <a:pt x="0" y="4"/>
                </a:moveTo>
                <a:lnTo>
                  <a:pt x="16" y="0"/>
                </a:lnTo>
                <a:lnTo>
                  <a:pt x="10" y="996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716360" y="5445000"/>
            <a:ext cx="1656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P2 TOE clade selected for tree in figure 6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4356000" y="6670800"/>
            <a:ext cx="158760" cy="1440"/>
          </a:xfrm>
          <a:custGeom>
            <a:avLst/>
            <a:gdLst/>
            <a:ahLst/>
            <a:rect l="l" t="t" r="r" b="b"/>
            <a:pathLst>
              <a:path w="100" h="1">
                <a:moveTo>
                  <a:pt x="0" y="0"/>
                </a:moveTo>
                <a:lnTo>
                  <a:pt x="100" y="1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5435640" y="620640"/>
            <a:ext cx="280836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000 datas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8T16:08:36Z</dcterms:created>
  <dc:creator>baileyp</dc:creator>
  <dc:description/>
  <dc:language>en-US</dc:language>
  <cp:lastModifiedBy>Janet Higgins</cp:lastModifiedBy>
  <dcterms:modified xsi:type="dcterms:W3CDTF">2010-01-06T11:56:40Z</dcterms:modified>
  <cp:revision>11</cp:revision>
  <dc:subject/>
  <dc:title>Slide 1</dc:title>
</cp:coreProperties>
</file>